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4" r:id="rId2"/>
  </p:sldIdLst>
  <p:sldSz cx="12241213" cy="6858000"/>
  <p:notesSz cx="6858000" cy="9144000"/>
  <p:defaultTextStyle>
    <a:defPPr>
      <a:defRPr lang="zh-CN"/>
    </a:defPPr>
    <a:lvl1pPr marL="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33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65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398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3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662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796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928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06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5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FF66CC"/>
    <a:srgbClr val="0000FF"/>
    <a:srgbClr val="DEA900"/>
    <a:srgbClr val="B48900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470" autoAdjust="0"/>
    <p:restoredTop sz="94774" autoAdjust="0"/>
  </p:normalViewPr>
  <p:slideViewPr>
    <p:cSldViewPr>
      <p:cViewPr>
        <p:scale>
          <a:sx n="96" d="100"/>
          <a:sy n="96" d="100"/>
        </p:scale>
        <p:origin x="-1560" y="-414"/>
      </p:cViewPr>
      <p:guideLst>
        <p:guide orient="horz" pos="2160"/>
        <p:guide pos="385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\Desktop\&#25311;&#21335;&#33445;&#36716;&#24405;&#32452;&#20998;&#26512;\&#33639;&#20809;&#23450;&#37327;&#39564;&#35777;&#36716;&#24405;&#32452;\2019-04-29%20202046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\Desktop\&#25311;&#21335;&#33445;&#36716;&#24405;&#32452;&#20998;&#26512;\&#33639;&#20809;&#23450;&#37327;&#39564;&#35777;&#36716;&#24405;&#32452;\2019-04-29%20202046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\Desktop\&#25311;&#21335;&#33445;&#36716;&#24405;&#32452;&#20998;&#26512;\&#33639;&#20809;&#23450;&#37327;&#39564;&#35777;&#36716;&#24405;&#32452;\2019-04-29%20202046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\Desktop\&#25311;&#21335;&#33445;&#36716;&#24405;&#32452;&#20998;&#26512;\&#33639;&#20809;&#23450;&#37327;&#39564;&#35777;&#36716;&#24405;&#32452;\2019-04-29%20202046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结果分析!$K$18</c:f>
              <c:strCache>
                <c:ptCount val="1"/>
                <c:pt idx="0">
                  <c:v>RNA-seq data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numRef>
              <c:f>结果分析!$L$17:$V$17</c:f>
              <c:numCache>
                <c:formatCode>General</c:formatCode>
                <c:ptCount val="11"/>
              </c:numCache>
            </c:numRef>
          </c:cat>
          <c:val>
            <c:numRef>
              <c:f>结果分析!$L$18:$V$18</c:f>
              <c:numCache>
                <c:formatCode>General</c:formatCode>
                <c:ptCount val="11"/>
                <c:pt idx="0">
                  <c:v>2.1547054899852367</c:v>
                </c:pt>
                <c:pt idx="1">
                  <c:v>1.73074102063973</c:v>
                </c:pt>
                <c:pt idx="2">
                  <c:v>1.6493400669978904</c:v>
                </c:pt>
                <c:pt idx="3">
                  <c:v>1.6353538515806301</c:v>
                </c:pt>
                <c:pt idx="4">
                  <c:v>1.4263363159919678</c:v>
                </c:pt>
                <c:pt idx="5">
                  <c:v>1.4172919628481098</c:v>
                </c:pt>
                <c:pt idx="6">
                  <c:v>1.3392738256111401</c:v>
                </c:pt>
                <c:pt idx="7">
                  <c:v>1.31038440775135</c:v>
                </c:pt>
                <c:pt idx="8">
                  <c:v>1.10721761110148</c:v>
                </c:pt>
                <c:pt idx="9">
                  <c:v>-1.6610463477940098</c:v>
                </c:pt>
                <c:pt idx="10">
                  <c:v>1.5634765486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637-4ED1-929D-E7982F958374}"/>
            </c:ext>
          </c:extLst>
        </c:ser>
        <c:ser>
          <c:idx val="1"/>
          <c:order val="1"/>
          <c:tx>
            <c:strRef>
              <c:f>结果分析!$K$19</c:f>
              <c:strCache>
                <c:ptCount val="1"/>
                <c:pt idx="0">
                  <c:v>real-time PCR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结果分析!$L$22:$V$22</c:f>
                <c:numCache>
                  <c:formatCode>General</c:formatCode>
                  <c:ptCount val="11"/>
                  <c:pt idx="0">
                    <c:v>0.30246212029808595</c:v>
                  </c:pt>
                  <c:pt idx="1">
                    <c:v>0.15787881506446441</c:v>
                  </c:pt>
                  <c:pt idx="2">
                    <c:v>0.37012325321730832</c:v>
                  </c:pt>
                  <c:pt idx="3">
                    <c:v>0.19358107714397188</c:v>
                  </c:pt>
                  <c:pt idx="4">
                    <c:v>7.5184149734100009E-2</c:v>
                  </c:pt>
                  <c:pt idx="5">
                    <c:v>0.2372029158187787</c:v>
                  </c:pt>
                  <c:pt idx="6">
                    <c:v>8.2198578068589226E-2</c:v>
                  </c:pt>
                  <c:pt idx="7">
                    <c:v>2.3123012618092392E-2</c:v>
                  </c:pt>
                  <c:pt idx="8">
                    <c:v>0.12220165408438351</c:v>
                  </c:pt>
                  <c:pt idx="9">
                    <c:v>6.6648880214178877E-2</c:v>
                  </c:pt>
                  <c:pt idx="10">
                    <c:v>0.269838025612711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结果分析!$L$17:$V$17</c:f>
              <c:numCache>
                <c:formatCode>General</c:formatCode>
                <c:ptCount val="11"/>
              </c:numCache>
            </c:numRef>
          </c:cat>
          <c:val>
            <c:numRef>
              <c:f>结果分析!$L$19:$V$19</c:f>
              <c:numCache>
                <c:formatCode>General</c:formatCode>
                <c:ptCount val="11"/>
                <c:pt idx="0">
                  <c:v>1.1382350921630859</c:v>
                </c:pt>
                <c:pt idx="1">
                  <c:v>1.2602965037028007</c:v>
                </c:pt>
                <c:pt idx="2">
                  <c:v>1.8524869283040475</c:v>
                </c:pt>
                <c:pt idx="3">
                  <c:v>1.1709060668945321</c:v>
                </c:pt>
                <c:pt idx="4">
                  <c:v>1.5139369964599452</c:v>
                </c:pt>
                <c:pt idx="5">
                  <c:v>1.3618863423665371</c:v>
                </c:pt>
                <c:pt idx="6">
                  <c:v>1.9235267639160165</c:v>
                </c:pt>
                <c:pt idx="7">
                  <c:v>1.7510058085123699</c:v>
                </c:pt>
                <c:pt idx="8">
                  <c:v>1.6937618255615241</c:v>
                </c:pt>
                <c:pt idx="9">
                  <c:v>-1.3075962066650286</c:v>
                </c:pt>
                <c:pt idx="10">
                  <c:v>1.68408203125002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637-4ED1-929D-E7982F9583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2107520"/>
        <c:axId val="190571648"/>
      </c:barChart>
      <c:catAx>
        <c:axId val="1821075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90571648"/>
        <c:crosses val="autoZero"/>
        <c:auto val="1"/>
        <c:lblAlgn val="ctr"/>
        <c:lblOffset val="100"/>
        <c:noMultiLvlLbl val="0"/>
      </c:catAx>
      <c:valAx>
        <c:axId val="190571648"/>
        <c:scaling>
          <c:orientation val="minMax"/>
          <c:max val="3"/>
          <c:min val="-2"/>
        </c:scaling>
        <c:delete val="0"/>
        <c:axPos val="b"/>
        <c:majorGridlines>
          <c:spPr>
            <a:ln w="3175">
              <a:solidFill>
                <a:schemeClr val="bg1">
                  <a:lumMod val="75000"/>
                </a:schemeClr>
              </a:solidFill>
            </a:ln>
          </c:spPr>
        </c:majorGridlines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sz="10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82107520"/>
        <c:crosses val="autoZero"/>
        <c:crossBetween val="between"/>
        <c:majorUnit val="1"/>
      </c:valAx>
    </c:plotArea>
    <c:plotVisOnly val="1"/>
    <c:dispBlanksAs val="gap"/>
    <c:showDLblsOverMax val="0"/>
  </c:chart>
  <c:spPr>
    <a:ln w="15875">
      <a:solidFill>
        <a:prstClr val="black"/>
      </a:solidFill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结果分析!$K$41</c:f>
              <c:strCache>
                <c:ptCount val="1"/>
                <c:pt idx="0">
                  <c:v>RNA-seq data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numRef>
              <c:f>结果分析!$L$40:$V$40</c:f>
              <c:numCache>
                <c:formatCode>General</c:formatCode>
                <c:ptCount val="11"/>
              </c:numCache>
            </c:numRef>
          </c:cat>
          <c:val>
            <c:numRef>
              <c:f>结果分析!$L$41:$V$41</c:f>
              <c:numCache>
                <c:formatCode>General</c:formatCode>
                <c:ptCount val="11"/>
                <c:pt idx="0">
                  <c:v>1.0356767556379245</c:v>
                </c:pt>
                <c:pt idx="1">
                  <c:v>1.0236051683410201</c:v>
                </c:pt>
                <c:pt idx="2">
                  <c:v>1.08856802599935</c:v>
                </c:pt>
                <c:pt idx="3">
                  <c:v>1.0398215751938698</c:v>
                </c:pt>
                <c:pt idx="4">
                  <c:v>1.0271679398771001</c:v>
                </c:pt>
                <c:pt idx="5">
                  <c:v>1.04338682060763</c:v>
                </c:pt>
                <c:pt idx="6">
                  <c:v>1.1589098158153999</c:v>
                </c:pt>
                <c:pt idx="7">
                  <c:v>1.27264858907509</c:v>
                </c:pt>
                <c:pt idx="8">
                  <c:v>1.06713800945083</c:v>
                </c:pt>
                <c:pt idx="9">
                  <c:v>-1.1366650782160101</c:v>
                </c:pt>
                <c:pt idx="10">
                  <c:v>1.11837553816286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46D-44CA-9F69-07B910B82ACB}"/>
            </c:ext>
          </c:extLst>
        </c:ser>
        <c:ser>
          <c:idx val="1"/>
          <c:order val="1"/>
          <c:tx>
            <c:strRef>
              <c:f>结果分析!$K$42</c:f>
              <c:strCache>
                <c:ptCount val="1"/>
                <c:pt idx="0">
                  <c:v>real-time PCR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结果分析!$L$45:$V$45</c:f>
                <c:numCache>
                  <c:formatCode>General</c:formatCode>
                  <c:ptCount val="11"/>
                  <c:pt idx="0">
                    <c:v>5.0834960532005993E-2</c:v>
                  </c:pt>
                  <c:pt idx="1">
                    <c:v>3.2355917273118449E-2</c:v>
                  </c:pt>
                  <c:pt idx="2">
                    <c:v>0.21164232700141022</c:v>
                  </c:pt>
                  <c:pt idx="3">
                    <c:v>0.16309149596598291</c:v>
                  </c:pt>
                  <c:pt idx="4">
                    <c:v>6.406906069416822E-2</c:v>
                  </c:pt>
                  <c:pt idx="5">
                    <c:v>0.16486913513713758</c:v>
                  </c:pt>
                  <c:pt idx="6">
                    <c:v>8.9261453389410064E-2</c:v>
                  </c:pt>
                  <c:pt idx="7">
                    <c:v>6.8809583251653372E-2</c:v>
                  </c:pt>
                  <c:pt idx="8">
                    <c:v>5.7511329020947514E-2</c:v>
                  </c:pt>
                  <c:pt idx="9">
                    <c:v>7.4942769697380299E-2</c:v>
                  </c:pt>
                  <c:pt idx="10">
                    <c:v>7.459279178981000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结果分析!$L$40:$V$40</c:f>
              <c:numCache>
                <c:formatCode>General</c:formatCode>
                <c:ptCount val="11"/>
              </c:numCache>
            </c:numRef>
          </c:cat>
          <c:val>
            <c:numRef>
              <c:f>结果分析!$L$42:$V$42</c:f>
              <c:numCache>
                <c:formatCode>General</c:formatCode>
                <c:ptCount val="11"/>
                <c:pt idx="0">
                  <c:v>0.43269030253092389</c:v>
                </c:pt>
                <c:pt idx="1">
                  <c:v>0.43915685017903588</c:v>
                </c:pt>
                <c:pt idx="2">
                  <c:v>0.66803105672201102</c:v>
                </c:pt>
                <c:pt idx="3">
                  <c:v>0.67383829752604896</c:v>
                </c:pt>
                <c:pt idx="4">
                  <c:v>0.50742721557617265</c:v>
                </c:pt>
                <c:pt idx="5">
                  <c:v>0.65870348612468432</c:v>
                </c:pt>
                <c:pt idx="6">
                  <c:v>0.68718083699544363</c:v>
                </c:pt>
                <c:pt idx="7">
                  <c:v>1.1211477915445967</c:v>
                </c:pt>
                <c:pt idx="8">
                  <c:v>0.74234644571940045</c:v>
                </c:pt>
                <c:pt idx="9">
                  <c:v>-1.1255970001220699</c:v>
                </c:pt>
                <c:pt idx="10">
                  <c:v>0.529593149820952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46D-44CA-9F69-07B910B82A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0265600"/>
        <c:axId val="190271488"/>
      </c:barChart>
      <c:catAx>
        <c:axId val="1902656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90271488"/>
        <c:crosses val="autoZero"/>
        <c:auto val="1"/>
        <c:lblAlgn val="ctr"/>
        <c:lblOffset val="100"/>
        <c:noMultiLvlLbl val="0"/>
      </c:catAx>
      <c:valAx>
        <c:axId val="190271488"/>
        <c:scaling>
          <c:orientation val="minMax"/>
          <c:max val="2"/>
          <c:min val="-2"/>
        </c:scaling>
        <c:delete val="0"/>
        <c:axPos val="b"/>
        <c:majorGridlines>
          <c:spPr>
            <a:ln w="3175">
              <a:solidFill>
                <a:schemeClr val="bg1">
                  <a:lumMod val="75000"/>
                </a:schemeClr>
              </a:solidFill>
            </a:ln>
          </c:spPr>
        </c:majorGridlines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90265600"/>
        <c:crosses val="autoZero"/>
        <c:crossBetween val="between"/>
        <c:majorUnit val="1"/>
      </c:valAx>
    </c:plotArea>
    <c:plotVisOnly val="1"/>
    <c:dispBlanksAs val="gap"/>
    <c:showDLblsOverMax val="0"/>
  </c:chart>
  <c:spPr>
    <a:ln w="15875">
      <a:solidFill>
        <a:prstClr val="black"/>
      </a:solidFill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结果分析!$K$64</c:f>
              <c:strCache>
                <c:ptCount val="1"/>
                <c:pt idx="0">
                  <c:v>RNA-seq data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numRef>
              <c:f>结果分析!$L$63:$V$63</c:f>
              <c:numCache>
                <c:formatCode>General</c:formatCode>
                <c:ptCount val="11"/>
              </c:numCache>
            </c:numRef>
          </c:cat>
          <c:val>
            <c:numRef>
              <c:f>结果分析!$L$64:$V$64</c:f>
              <c:numCache>
                <c:formatCode>General</c:formatCode>
                <c:ptCount val="11"/>
                <c:pt idx="0">
                  <c:v>2.3408648652361301</c:v>
                </c:pt>
                <c:pt idx="1">
                  <c:v>1.8481777461073401</c:v>
                </c:pt>
                <c:pt idx="2">
                  <c:v>2.0771218855877862</c:v>
                </c:pt>
                <c:pt idx="3">
                  <c:v>1.6734468452146398</c:v>
                </c:pt>
                <c:pt idx="4">
                  <c:v>1.90086894215082</c:v>
                </c:pt>
                <c:pt idx="5">
                  <c:v>1.6032324908429698</c:v>
                </c:pt>
                <c:pt idx="6">
                  <c:v>2.3198516633744033</c:v>
                </c:pt>
                <c:pt idx="7">
                  <c:v>2.681439268680609</c:v>
                </c:pt>
                <c:pt idx="8">
                  <c:v>1.6799697164510499</c:v>
                </c:pt>
                <c:pt idx="9">
                  <c:v>-1.14156708432868</c:v>
                </c:pt>
                <c:pt idx="10">
                  <c:v>2.54011307925700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A9A-4D3A-B58F-A7CBBCC9989D}"/>
            </c:ext>
          </c:extLst>
        </c:ser>
        <c:ser>
          <c:idx val="1"/>
          <c:order val="1"/>
          <c:tx>
            <c:strRef>
              <c:f>结果分析!$K$65</c:f>
              <c:strCache>
                <c:ptCount val="1"/>
                <c:pt idx="0">
                  <c:v>real-time PCR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结果分析!$L$68:$V$68</c:f>
                <c:numCache>
                  <c:formatCode>General</c:formatCode>
                  <c:ptCount val="11"/>
                  <c:pt idx="0">
                    <c:v>5.6919540456133712E-2</c:v>
                  </c:pt>
                  <c:pt idx="1">
                    <c:v>0.12158980414637115</c:v>
                  </c:pt>
                  <c:pt idx="2">
                    <c:v>3.3440704174164795E-2</c:v>
                  </c:pt>
                  <c:pt idx="3">
                    <c:v>4.9011506643582094E-2</c:v>
                  </c:pt>
                  <c:pt idx="4">
                    <c:v>2.9864553394418767E-2</c:v>
                  </c:pt>
                  <c:pt idx="5">
                    <c:v>0.21203112617769873</c:v>
                  </c:pt>
                  <c:pt idx="6">
                    <c:v>9.4214045782968422E-3</c:v>
                  </c:pt>
                  <c:pt idx="7">
                    <c:v>2.4321660278655181E-2</c:v>
                  </c:pt>
                  <c:pt idx="8">
                    <c:v>3.1160547271012782E-2</c:v>
                  </c:pt>
                  <c:pt idx="9">
                    <c:v>7.2698248333167279E-2</c:v>
                  </c:pt>
                  <c:pt idx="10">
                    <c:v>4.498965546212256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结果分析!$L$63:$V$63</c:f>
              <c:numCache>
                <c:formatCode>General</c:formatCode>
                <c:ptCount val="11"/>
              </c:numCache>
            </c:numRef>
          </c:cat>
          <c:val>
            <c:numRef>
              <c:f>结果分析!$L$65:$V$65</c:f>
              <c:numCache>
                <c:formatCode>General</c:formatCode>
                <c:ptCount val="11"/>
                <c:pt idx="0">
                  <c:v>1.7458184560139978</c:v>
                </c:pt>
                <c:pt idx="1">
                  <c:v>1.4306424458821598</c:v>
                </c:pt>
                <c:pt idx="2">
                  <c:v>1.7221043904622289</c:v>
                </c:pt>
                <c:pt idx="3">
                  <c:v>1.1974493662516281</c:v>
                </c:pt>
                <c:pt idx="4">
                  <c:v>1.29405148824056</c:v>
                </c:pt>
                <c:pt idx="5">
                  <c:v>0.94377454121908011</c:v>
                </c:pt>
                <c:pt idx="6">
                  <c:v>1.5669937133789058</c:v>
                </c:pt>
                <c:pt idx="7">
                  <c:v>2.033501942952515</c:v>
                </c:pt>
                <c:pt idx="8">
                  <c:v>0.99735514322916607</c:v>
                </c:pt>
                <c:pt idx="9">
                  <c:v>-1.3703695933024078</c:v>
                </c:pt>
                <c:pt idx="10">
                  <c:v>1.6073735555013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A9A-4D3A-B58F-A7CBBCC998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0551168"/>
        <c:axId val="190552704"/>
      </c:barChart>
      <c:catAx>
        <c:axId val="1905511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90552704"/>
        <c:crosses val="autoZero"/>
        <c:auto val="1"/>
        <c:lblAlgn val="ctr"/>
        <c:lblOffset val="100"/>
        <c:noMultiLvlLbl val="0"/>
      </c:catAx>
      <c:valAx>
        <c:axId val="190552704"/>
        <c:scaling>
          <c:orientation val="minMax"/>
          <c:max val="3"/>
          <c:min val="-2"/>
        </c:scaling>
        <c:delete val="0"/>
        <c:axPos val="b"/>
        <c:majorGridlines>
          <c:spPr>
            <a:ln w="3175">
              <a:solidFill>
                <a:schemeClr val="bg1">
                  <a:lumMod val="75000"/>
                </a:schemeClr>
              </a:solidFill>
            </a:ln>
          </c:spPr>
        </c:majorGridlines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90551168"/>
        <c:crosses val="autoZero"/>
        <c:crossBetween val="between"/>
        <c:majorUnit val="1"/>
      </c:valAx>
    </c:plotArea>
    <c:plotVisOnly val="1"/>
    <c:dispBlanksAs val="gap"/>
    <c:showDLblsOverMax val="0"/>
  </c:chart>
  <c:spPr>
    <a:ln w="15875">
      <a:solidFill>
        <a:prstClr val="black"/>
      </a:solidFill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结果分析!$K$88</c:f>
              <c:strCache>
                <c:ptCount val="1"/>
                <c:pt idx="0">
                  <c:v>RNA-seq data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numRef>
              <c:f>结果分析!$L$87:$V$87</c:f>
              <c:numCache>
                <c:formatCode>General</c:formatCode>
                <c:ptCount val="11"/>
              </c:numCache>
            </c:numRef>
          </c:cat>
          <c:val>
            <c:numRef>
              <c:f>结果分析!$L$88:$V$88</c:f>
              <c:numCache>
                <c:formatCode>General</c:formatCode>
                <c:ptCount val="11"/>
                <c:pt idx="0">
                  <c:v>3.4507129896814077</c:v>
                </c:pt>
                <c:pt idx="1">
                  <c:v>2.5488198361001877</c:v>
                </c:pt>
                <c:pt idx="2">
                  <c:v>2.6158261608158377</c:v>
                </c:pt>
                <c:pt idx="3">
                  <c:v>2.2621106917668601</c:v>
                </c:pt>
                <c:pt idx="4">
                  <c:v>2.2940770080165862</c:v>
                </c:pt>
                <c:pt idx="5">
                  <c:v>1.9691544191996999</c:v>
                </c:pt>
                <c:pt idx="6">
                  <c:v>2.4900193806702777</c:v>
                </c:pt>
                <c:pt idx="7">
                  <c:v>2.7064876437345702</c:v>
                </c:pt>
                <c:pt idx="8">
                  <c:v>1.7111652142172795</c:v>
                </c:pt>
                <c:pt idx="9">
                  <c:v>-1.6678759410659301</c:v>
                </c:pt>
                <c:pt idx="10">
                  <c:v>2.96875928857483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508-4B58-A468-D628FD244815}"/>
            </c:ext>
          </c:extLst>
        </c:ser>
        <c:ser>
          <c:idx val="1"/>
          <c:order val="1"/>
          <c:tx>
            <c:strRef>
              <c:f>结果分析!$K$89</c:f>
              <c:strCache>
                <c:ptCount val="1"/>
                <c:pt idx="0">
                  <c:v>real-time PCR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结果分析!$L$92:$V$92</c:f>
                <c:numCache>
                  <c:formatCode>General</c:formatCode>
                  <c:ptCount val="11"/>
                  <c:pt idx="0">
                    <c:v>0.14300936295926941</c:v>
                  </c:pt>
                  <c:pt idx="1">
                    <c:v>0.20098580879245107</c:v>
                  </c:pt>
                  <c:pt idx="2">
                    <c:v>0.11029179754426979</c:v>
                  </c:pt>
                  <c:pt idx="3">
                    <c:v>0.1270918409807954</c:v>
                  </c:pt>
                  <c:pt idx="4">
                    <c:v>0.12211161369755305</c:v>
                  </c:pt>
                  <c:pt idx="5">
                    <c:v>0.37194840492328812</c:v>
                  </c:pt>
                  <c:pt idx="6">
                    <c:v>0.34030166817746427</c:v>
                  </c:pt>
                  <c:pt idx="7">
                    <c:v>0.34212363655774436</c:v>
                  </c:pt>
                  <c:pt idx="8">
                    <c:v>0.29588245397462742</c:v>
                  </c:pt>
                  <c:pt idx="9">
                    <c:v>0.29572617528496387</c:v>
                  </c:pt>
                  <c:pt idx="10">
                    <c:v>9.5598077339164068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结果分析!$L$87:$V$87</c:f>
              <c:numCache>
                <c:formatCode>General</c:formatCode>
                <c:ptCount val="11"/>
              </c:numCache>
            </c:numRef>
          </c:cat>
          <c:val>
            <c:numRef>
              <c:f>结果分析!$L$89:$V$89</c:f>
              <c:numCache>
                <c:formatCode>General</c:formatCode>
                <c:ptCount val="11"/>
                <c:pt idx="0">
                  <c:v>2.45136324564616</c:v>
                </c:pt>
                <c:pt idx="1">
                  <c:v>2.2517820994059257</c:v>
                </c:pt>
                <c:pt idx="2">
                  <c:v>2.9065602620442714</c:v>
                </c:pt>
                <c:pt idx="3">
                  <c:v>1.6945171356201327</c:v>
                </c:pt>
                <c:pt idx="4">
                  <c:v>2.3005612691243491</c:v>
                </c:pt>
                <c:pt idx="5">
                  <c:v>1.6469573974609375</c:v>
                </c:pt>
                <c:pt idx="6">
                  <c:v>2.8033396402994812</c:v>
                </c:pt>
                <c:pt idx="7">
                  <c:v>2.6633599599202471</c:v>
                </c:pt>
                <c:pt idx="8">
                  <c:v>1.9487705230713099</c:v>
                </c:pt>
                <c:pt idx="9">
                  <c:v>-1.552368799845377</c:v>
                </c:pt>
                <c:pt idx="10">
                  <c:v>2.76186243693033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508-4B58-A468-D628FD2448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0341120"/>
        <c:axId val="190342656"/>
      </c:barChart>
      <c:catAx>
        <c:axId val="1903411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90342656"/>
        <c:crosses val="autoZero"/>
        <c:auto val="1"/>
        <c:lblAlgn val="ctr"/>
        <c:lblOffset val="100"/>
        <c:noMultiLvlLbl val="0"/>
      </c:catAx>
      <c:valAx>
        <c:axId val="190342656"/>
        <c:scaling>
          <c:orientation val="minMax"/>
          <c:max val="4"/>
          <c:min val="-2"/>
        </c:scaling>
        <c:delete val="0"/>
        <c:axPos val="b"/>
        <c:majorGridlines>
          <c:spPr>
            <a:ln w="3175">
              <a:solidFill>
                <a:schemeClr val="bg1">
                  <a:lumMod val="75000"/>
                </a:schemeClr>
              </a:solidFill>
            </a:ln>
          </c:spPr>
        </c:majorGridlines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>
                <a:solidFill>
                  <a:schemeClr val="tx1"/>
                </a:solidFill>
              </a:defRPr>
            </a:pPr>
            <a:endParaRPr lang="en-US"/>
          </a:p>
        </c:txPr>
        <c:crossAx val="190341120"/>
        <c:crosses val="autoZero"/>
        <c:crossBetween val="between"/>
        <c:majorUnit val="1"/>
      </c:valAx>
    </c:plotArea>
    <c:plotVisOnly val="1"/>
    <c:dispBlanksAs val="gap"/>
    <c:showDLblsOverMax val="0"/>
  </c:chart>
  <c:spPr>
    <a:noFill/>
    <a:ln w="15875">
      <a:solidFill>
        <a:prstClr val="black"/>
      </a:solidFill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98A7FA-6879-4E0B-9967-F3ACD223DC6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69888" y="685800"/>
            <a:ext cx="61182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51331E-9B3F-403A-90EA-E393717398A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5057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33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65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398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53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62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796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928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06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18093" y="2130428"/>
            <a:ext cx="1040503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36183" y="3886200"/>
            <a:ext cx="8568849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6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7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9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74881" y="274642"/>
            <a:ext cx="2754273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12061" y="274642"/>
            <a:ext cx="8058797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66973" y="4406903"/>
            <a:ext cx="1040503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66973" y="2906713"/>
            <a:ext cx="10405030" cy="150018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5713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6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9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3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66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79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92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06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12061" y="1600204"/>
            <a:ext cx="540653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22616" y="1600204"/>
            <a:ext cx="540653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2060" y="1535115"/>
            <a:ext cx="5408662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3" indent="0">
              <a:buNone/>
              <a:defRPr sz="2100" b="1"/>
            </a:lvl2pPr>
            <a:lvl3pPr marL="914265" indent="0">
              <a:buNone/>
              <a:defRPr sz="1800" b="1"/>
            </a:lvl3pPr>
            <a:lvl4pPr marL="1371398" indent="0">
              <a:buNone/>
              <a:defRPr sz="1600" b="1"/>
            </a:lvl4pPr>
            <a:lvl5pPr marL="1828530" indent="0">
              <a:buNone/>
              <a:defRPr sz="1600" b="1"/>
            </a:lvl5pPr>
            <a:lvl6pPr marL="2285662" indent="0">
              <a:buNone/>
              <a:defRPr sz="1600" b="1"/>
            </a:lvl6pPr>
            <a:lvl7pPr marL="2742796" indent="0">
              <a:buNone/>
              <a:defRPr sz="1600" b="1"/>
            </a:lvl7pPr>
            <a:lvl8pPr marL="3199928" indent="0">
              <a:buNone/>
              <a:defRPr sz="1600" b="1"/>
            </a:lvl8pPr>
            <a:lvl9pPr marL="365706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2060" y="2174876"/>
            <a:ext cx="5408662" cy="395128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18370" y="1535115"/>
            <a:ext cx="5410786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3" indent="0">
              <a:buNone/>
              <a:defRPr sz="2100" b="1"/>
            </a:lvl2pPr>
            <a:lvl3pPr marL="914265" indent="0">
              <a:buNone/>
              <a:defRPr sz="1800" b="1"/>
            </a:lvl3pPr>
            <a:lvl4pPr marL="1371398" indent="0">
              <a:buNone/>
              <a:defRPr sz="1600" b="1"/>
            </a:lvl4pPr>
            <a:lvl5pPr marL="1828530" indent="0">
              <a:buNone/>
              <a:defRPr sz="1600" b="1"/>
            </a:lvl5pPr>
            <a:lvl6pPr marL="2285662" indent="0">
              <a:buNone/>
              <a:defRPr sz="1600" b="1"/>
            </a:lvl6pPr>
            <a:lvl7pPr marL="2742796" indent="0">
              <a:buNone/>
              <a:defRPr sz="1600" b="1"/>
            </a:lvl7pPr>
            <a:lvl8pPr marL="3199928" indent="0">
              <a:buNone/>
              <a:defRPr sz="1600" b="1"/>
            </a:lvl8pPr>
            <a:lvl9pPr marL="365706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18370" y="2174876"/>
            <a:ext cx="5410786" cy="395128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12065" y="273049"/>
            <a:ext cx="4027275" cy="116205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85976" y="273053"/>
            <a:ext cx="6843178" cy="5853113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12065" y="1435103"/>
            <a:ext cx="4027275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33" indent="0">
              <a:buNone/>
              <a:defRPr sz="1200"/>
            </a:lvl2pPr>
            <a:lvl3pPr marL="914265" indent="0">
              <a:buNone/>
              <a:defRPr sz="1000"/>
            </a:lvl3pPr>
            <a:lvl4pPr marL="1371398" indent="0">
              <a:buNone/>
              <a:defRPr sz="1000"/>
            </a:lvl4pPr>
            <a:lvl5pPr marL="1828530" indent="0">
              <a:buNone/>
              <a:defRPr sz="1000"/>
            </a:lvl5pPr>
            <a:lvl6pPr marL="2285662" indent="0">
              <a:buNone/>
              <a:defRPr sz="1000"/>
            </a:lvl6pPr>
            <a:lvl7pPr marL="2742796" indent="0">
              <a:buNone/>
              <a:defRPr sz="1000"/>
            </a:lvl7pPr>
            <a:lvl8pPr marL="3199928" indent="0">
              <a:buNone/>
              <a:defRPr sz="1000"/>
            </a:lvl8pPr>
            <a:lvl9pPr marL="365706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99363" y="4800603"/>
            <a:ext cx="7344728" cy="566739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399363" y="612776"/>
            <a:ext cx="7344728" cy="4114800"/>
          </a:xfrm>
        </p:spPr>
        <p:txBody>
          <a:bodyPr/>
          <a:lstStyle>
            <a:lvl1pPr marL="0" indent="0">
              <a:buNone/>
              <a:defRPr sz="3300"/>
            </a:lvl1pPr>
            <a:lvl2pPr marL="457133" indent="0">
              <a:buNone/>
              <a:defRPr sz="2800"/>
            </a:lvl2pPr>
            <a:lvl3pPr marL="914265" indent="0">
              <a:buNone/>
              <a:defRPr sz="2400"/>
            </a:lvl3pPr>
            <a:lvl4pPr marL="1371398" indent="0">
              <a:buNone/>
              <a:defRPr sz="2100"/>
            </a:lvl4pPr>
            <a:lvl5pPr marL="1828530" indent="0">
              <a:buNone/>
              <a:defRPr sz="2100"/>
            </a:lvl5pPr>
            <a:lvl6pPr marL="2285662" indent="0">
              <a:buNone/>
              <a:defRPr sz="2100"/>
            </a:lvl6pPr>
            <a:lvl7pPr marL="2742796" indent="0">
              <a:buNone/>
              <a:defRPr sz="2100"/>
            </a:lvl7pPr>
            <a:lvl8pPr marL="3199928" indent="0">
              <a:buNone/>
              <a:defRPr sz="2100"/>
            </a:lvl8pPr>
            <a:lvl9pPr marL="3657060" indent="0">
              <a:buNone/>
              <a:defRPr sz="21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99363" y="5367340"/>
            <a:ext cx="7344728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133" indent="0">
              <a:buNone/>
              <a:defRPr sz="1200"/>
            </a:lvl2pPr>
            <a:lvl3pPr marL="914265" indent="0">
              <a:buNone/>
              <a:defRPr sz="1000"/>
            </a:lvl3pPr>
            <a:lvl4pPr marL="1371398" indent="0">
              <a:buNone/>
              <a:defRPr sz="1000"/>
            </a:lvl4pPr>
            <a:lvl5pPr marL="1828530" indent="0">
              <a:buNone/>
              <a:defRPr sz="1000"/>
            </a:lvl5pPr>
            <a:lvl6pPr marL="2285662" indent="0">
              <a:buNone/>
              <a:defRPr sz="1000"/>
            </a:lvl6pPr>
            <a:lvl7pPr marL="2742796" indent="0">
              <a:buNone/>
              <a:defRPr sz="1000"/>
            </a:lvl7pPr>
            <a:lvl8pPr marL="3199928" indent="0">
              <a:buNone/>
              <a:defRPr sz="1000"/>
            </a:lvl8pPr>
            <a:lvl9pPr marL="365706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12061" y="274637"/>
            <a:ext cx="11017092" cy="1143000"/>
          </a:xfrm>
          <a:prstGeom prst="rect">
            <a:avLst/>
          </a:prstGeom>
        </p:spPr>
        <p:txBody>
          <a:bodyPr vert="horz" lIns="91427" tIns="45713" rIns="91427" bIns="45713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2061" y="1600204"/>
            <a:ext cx="11017092" cy="4525963"/>
          </a:xfrm>
          <a:prstGeom prst="rect">
            <a:avLst/>
          </a:prstGeom>
        </p:spPr>
        <p:txBody>
          <a:bodyPr vert="horz" lIns="91427" tIns="45713" rIns="91427" bIns="45713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12061" y="6356353"/>
            <a:ext cx="2856283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182416" y="6356353"/>
            <a:ext cx="3876384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772869" y="6356353"/>
            <a:ext cx="2856283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65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50" indent="-342850" algn="l" defTabSz="914265" rtl="0" eaLnBrk="1" latinLnBrk="0" hangingPunct="1">
        <a:spcBef>
          <a:spcPct val="20000"/>
        </a:spcBef>
        <a:buFont typeface="Arial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41" indent="-285707" algn="l" defTabSz="914265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32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964" indent="-228566" algn="l" defTabSz="914265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096" indent="-228566" algn="l" defTabSz="914265" rtl="0" eaLnBrk="1" latinLnBrk="0" hangingPunct="1">
        <a:spcBef>
          <a:spcPct val="20000"/>
        </a:spcBef>
        <a:buFont typeface="Arial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29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362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494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626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33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65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98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3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662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796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928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06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图表 5"/>
          <p:cNvGraphicFramePr/>
          <p:nvPr/>
        </p:nvGraphicFramePr>
        <p:xfrm>
          <a:off x="3230591" y="1535667"/>
          <a:ext cx="1576190" cy="38884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矩形 6"/>
          <p:cNvSpPr/>
          <p:nvPr/>
        </p:nvSpPr>
        <p:spPr>
          <a:xfrm>
            <a:off x="3610509" y="1124744"/>
            <a:ext cx="116472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PHD6-control vs. WT-control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8" name="图表 7"/>
          <p:cNvGraphicFramePr/>
          <p:nvPr/>
        </p:nvGraphicFramePr>
        <p:xfrm>
          <a:off x="4848790" y="1535667"/>
          <a:ext cx="1605378" cy="38884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矩形 8"/>
          <p:cNvSpPr/>
          <p:nvPr/>
        </p:nvSpPr>
        <p:spPr>
          <a:xfrm>
            <a:off x="5129994" y="1124885"/>
            <a:ext cx="132398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PHD6-drought </a:t>
            </a:r>
          </a:p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vs. WT-drought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0" name="图表 9"/>
          <p:cNvGraphicFramePr/>
          <p:nvPr/>
        </p:nvGraphicFramePr>
        <p:xfrm>
          <a:off x="6488711" y="1535667"/>
          <a:ext cx="1644296" cy="38884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矩形 10"/>
          <p:cNvSpPr/>
          <p:nvPr/>
        </p:nvSpPr>
        <p:spPr>
          <a:xfrm>
            <a:off x="6732381" y="1124885"/>
            <a:ext cx="132398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PHD6-drought </a:t>
            </a:r>
          </a:p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vs. PHD6-control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2" name="图表 11"/>
          <p:cNvGraphicFramePr/>
          <p:nvPr/>
        </p:nvGraphicFramePr>
        <p:xfrm>
          <a:off x="8172078" y="1535667"/>
          <a:ext cx="1692944" cy="38884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" name="矩形 12"/>
          <p:cNvSpPr/>
          <p:nvPr/>
        </p:nvSpPr>
        <p:spPr>
          <a:xfrm>
            <a:off x="8507266" y="1124885"/>
            <a:ext cx="117687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WT-drought</a:t>
            </a:r>
          </a:p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vs. WT-control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1800126" y="1658817"/>
            <a:ext cx="10794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T4G23150_CRK7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1800126" y="1967715"/>
            <a:ext cx="11443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T2G29490_GSTU1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1800126" y="2327755"/>
            <a:ext cx="106603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T1G30900_VSR6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1800126" y="2615787"/>
            <a:ext cx="10012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T3G57240_BG3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矩形 25"/>
          <p:cNvSpPr/>
          <p:nvPr/>
        </p:nvSpPr>
        <p:spPr>
          <a:xfrm>
            <a:off x="2020789" y="2954961"/>
            <a:ext cx="7211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T1G13470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矩形 26"/>
          <p:cNvSpPr/>
          <p:nvPr/>
        </p:nvSpPr>
        <p:spPr>
          <a:xfrm>
            <a:off x="1800126" y="3274492"/>
            <a:ext cx="9816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T4G30640_RNI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矩形 27"/>
          <p:cNvSpPr/>
          <p:nvPr/>
        </p:nvSpPr>
        <p:spPr>
          <a:xfrm>
            <a:off x="1800126" y="3562524"/>
            <a:ext cx="10599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T1G14880_PCR1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2020789" y="3850956"/>
            <a:ext cx="7211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T4G34380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2020789" y="4170887"/>
            <a:ext cx="7211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T4G18250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2020789" y="4479785"/>
            <a:ext cx="7211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T5G59680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2020789" y="4829192"/>
            <a:ext cx="7211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T2G04515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6" name="组合 37"/>
          <p:cNvGrpSpPr/>
          <p:nvPr/>
        </p:nvGrpSpPr>
        <p:grpSpPr>
          <a:xfrm>
            <a:off x="2034472" y="5210498"/>
            <a:ext cx="1258812" cy="488178"/>
            <a:chOff x="1361116" y="5375639"/>
            <a:chExt cx="1232346" cy="488178"/>
          </a:xfrm>
        </p:grpSpPr>
        <p:sp>
          <p:nvSpPr>
            <p:cNvPr id="33" name="矩形 32"/>
            <p:cNvSpPr/>
            <p:nvPr/>
          </p:nvSpPr>
          <p:spPr>
            <a:xfrm>
              <a:off x="1361116" y="5487756"/>
              <a:ext cx="144016" cy="7200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" name="矩形 33"/>
            <p:cNvSpPr/>
            <p:nvPr/>
          </p:nvSpPr>
          <p:spPr>
            <a:xfrm>
              <a:off x="1363539" y="5682514"/>
              <a:ext cx="144016" cy="7200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513342" y="5375639"/>
              <a:ext cx="1080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itchFamily="18" charset="0"/>
                  <a:cs typeface="Times New Roman" pitchFamily="18" charset="0"/>
                </a:rPr>
                <a:t>real-time PCR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502709" y="5586818"/>
              <a:ext cx="1080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itchFamily="18" charset="0"/>
                  <a:cs typeface="Times New Roman" pitchFamily="18" charset="0"/>
                </a:rPr>
                <a:t>RNA-</a:t>
              </a:r>
              <a:r>
                <a:rPr lang="en-US" altLang="zh-CN" sz="1200" dirty="0" err="1">
                  <a:latin typeface="Times New Roman" pitchFamily="18" charset="0"/>
                  <a:cs typeface="Times New Roman" pitchFamily="18" charset="0"/>
                </a:rPr>
                <a:t>seq</a:t>
              </a:r>
              <a:r>
                <a:rPr lang="en-US" altLang="zh-CN" sz="1200" dirty="0">
                  <a:latin typeface="Times New Roman" pitchFamily="18" charset="0"/>
                  <a:cs typeface="Times New Roman" pitchFamily="18" charset="0"/>
                </a:rPr>
                <a:t> data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7" name="TextBox 36"/>
          <p:cNvSpPr txBox="1"/>
          <p:nvPr/>
        </p:nvSpPr>
        <p:spPr>
          <a:xfrm>
            <a:off x="5731444" y="5496107"/>
            <a:ext cx="16917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Log2 fold change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2016150" y="6021288"/>
            <a:ext cx="829107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S1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71</TotalTime>
  <Words>37</Words>
  <Application>Microsoft Office PowerPoint</Application>
  <PresentationFormat>Custom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HD6-EX AT. Drought stress</dc:title>
  <dc:creator>Wenli Quan</dc:creator>
  <cp:lastModifiedBy>Colonia, Norbeliza</cp:lastModifiedBy>
  <cp:revision>1468</cp:revision>
  <dcterms:created xsi:type="dcterms:W3CDTF">2018-01-22T02:45:40Z</dcterms:created>
  <dcterms:modified xsi:type="dcterms:W3CDTF">2019-12-04T02:05:31Z</dcterms:modified>
</cp:coreProperties>
</file>